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905" autoAdjust="0"/>
  </p:normalViewPr>
  <p:slideViewPr>
    <p:cSldViewPr snapToGrid="0">
      <p:cViewPr varScale="1">
        <p:scale>
          <a:sx n="98" d="100"/>
          <a:sy n="98" d="100"/>
        </p:scale>
        <p:origin x="8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5A5275-367F-6AA1-F3F5-475A86F327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01681B9-7057-DC9C-BFF7-E51BE1639C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DD89C0-F3D0-231E-CEBF-1E8C81072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C450E5-B9B7-1BAD-7930-2A6EA1DE9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81750A-CD5A-6C6C-44A2-B164A0AF9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0662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1A17AB-8F0D-7029-089F-C830903E61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F0B27A9-015D-5671-B7AF-2D87169CD4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458DFE-211E-D990-E6E7-1F425E399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272C09-F6AE-BF2E-3500-B04626EF2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B62F5C-DEB5-80F7-089B-C8275E8B3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0538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F722C7B-47B8-3335-D52B-DE9C5C0BDE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9DDD493-F222-7296-5E1B-823A0C893E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F20D953-4F8F-1681-1D41-9F433B8A9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334B88-4B29-6605-D6EB-B5673DAC7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CC0FD4-A90D-74AE-542C-033EA94EE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8525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C73737-AE5C-E6CA-57BA-761D30AE1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AFA75FE-DD31-26C5-47E6-FB051D3223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9EF3E4-31A9-4AB1-66A0-8D8AAB9CA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8B659F-E1F7-6754-739A-F60937D21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C6317E-AC9E-10A3-4BBA-8FB43BD2F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684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F5C21A-C7F8-59E1-0764-AFB313105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003CF80-9AE1-4720-49E2-BCF1F16823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D4D693-96CB-F63D-2C56-60913F9B6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8FBA2B-105C-E40B-67E2-2296B8F9B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DDD4D0-D8FC-63D1-388B-685B848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4481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BD7D67-F505-A168-64EA-AB469CD82B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D0ED68-0391-CC59-5E87-499BB3E722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880886D-B608-3F22-978E-8E334ED449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F0D6FD-CF09-95A5-DCF2-4B07EEB66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762482-6BD7-0C54-D5EB-B6F929FDE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202365-320B-9DA0-B63C-58CDBF686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35005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129066-D197-0AF8-DE3C-E3C8A878CE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A110440-B13F-A068-C5F8-E3103953B3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40F0FBC-1500-4F3C-C115-ADA715C804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A389908-25EC-5972-5A3C-2AE426D423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6109421-6730-5D17-33AC-ED5CAEB811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D392866-17D8-0CCA-1905-D2E15BD9C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48FE7E8-4E4D-8921-573D-1D0611245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0225AB1-D9D2-484A-9AF8-02AB33AFC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142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AA101F-DC27-824D-DE20-D71FE283E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3B29550-AA63-2F41-AE3B-13C71A7CF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B94368B-FE37-B35E-DF9B-CB8D19F33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8FFEEB7-920B-DCB1-8811-C9078DACF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610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522BBB6-A4B2-4F57-0045-71539FB7A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F3EA768-2896-9B5C-AE20-3D4A8530D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D33E13D-99B5-5386-67BB-ED2D0A213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9589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702795-D4A5-FC45-9262-BF3E42C04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CA4149-32D8-9F76-EF88-C87AA7C88F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5CD46A0-7FEB-4F54-B2F7-5B0C45AE37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FDF086-1A81-9F2E-DDCB-ED4EC5372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C9AEE51-E42D-E528-95DF-9DC5A0AB6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38C7070-8730-62B3-B97D-16DE777CC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1036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6F758F-DB47-1333-E275-6DB489AF6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3B3C319-9F01-5CCD-7D79-F6783D47B6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5053128-97EC-8805-5381-3D7E1F6CEE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9313D2-B3E0-3151-286B-8B2E9A7B5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1CA498-B34B-9F1B-0224-A8AD1A380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B28E34-744A-11FE-8041-8F5A1C789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7252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C326384-668C-BCC0-AC6C-87CA629068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73F8136-A306-5E66-B573-B52FE96D3D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C342CE-1094-172A-05DC-9D64EE99CF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857A8-82C5-43CD-B2AD-527CE76E062E}" type="datetimeFigureOut">
              <a:rPr lang="zh-CN" altLang="en-US" smtClean="0"/>
              <a:t>2024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3C54AC-EF09-59C5-63A6-CABDFAAA49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002646-D958-B14F-F79D-A7BF4E65D9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A4049-6929-42CF-B9AE-16A13023C9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196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组合 57">
            <a:extLst>
              <a:ext uri="{FF2B5EF4-FFF2-40B4-BE49-F238E27FC236}">
                <a16:creationId xmlns:a16="http://schemas.microsoft.com/office/drawing/2014/main" id="{B73C8FDC-EFC5-0EC8-72A5-D081B78994F3}"/>
              </a:ext>
            </a:extLst>
          </p:cNvPr>
          <p:cNvGrpSpPr/>
          <p:nvPr/>
        </p:nvGrpSpPr>
        <p:grpSpPr>
          <a:xfrm>
            <a:off x="1551185" y="239703"/>
            <a:ext cx="5729050" cy="6378593"/>
            <a:chOff x="254287" y="239703"/>
            <a:chExt cx="5729050" cy="6378593"/>
          </a:xfrm>
        </p:grpSpPr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ED7107D3-8FE8-B6CC-D66F-37AFD4DEDF09}"/>
                </a:ext>
              </a:extLst>
            </p:cNvPr>
            <p:cNvSpPr/>
            <p:nvPr/>
          </p:nvSpPr>
          <p:spPr>
            <a:xfrm>
              <a:off x="691443" y="651836"/>
              <a:ext cx="2964179" cy="708549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identified through Medline, Embase, Scopus, Web of Science, Cochrane Library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2593)</a:t>
              </a:r>
            </a:p>
          </p:txBody>
        </p:sp>
        <p:sp>
          <p:nvSpPr>
            <p:cNvPr id="8" name="object 20">
              <a:extLst>
                <a:ext uri="{FF2B5EF4-FFF2-40B4-BE49-F238E27FC236}">
                  <a16:creationId xmlns:a16="http://schemas.microsoft.com/office/drawing/2014/main" id="{E1FC0E54-5C02-B824-A530-38BCF8668383}"/>
                </a:ext>
              </a:extLst>
            </p:cNvPr>
            <p:cNvSpPr/>
            <p:nvPr/>
          </p:nvSpPr>
          <p:spPr>
            <a:xfrm>
              <a:off x="254287" y="651836"/>
              <a:ext cx="262340" cy="1417320"/>
            </a:xfrm>
            <a:custGeom>
              <a:avLst/>
              <a:gdLst/>
              <a:ahLst/>
              <a:cxnLst/>
              <a:rect l="l" t="t" r="r" b="b"/>
              <a:pathLst>
                <a:path w="262890" h="1276985">
                  <a:moveTo>
                    <a:pt x="219075" y="0"/>
                  </a:moveTo>
                  <a:lnTo>
                    <a:pt x="43815" y="0"/>
                  </a:lnTo>
                  <a:lnTo>
                    <a:pt x="26762" y="3434"/>
                  </a:lnTo>
                  <a:lnTo>
                    <a:pt x="12834" y="12811"/>
                  </a:lnTo>
                  <a:lnTo>
                    <a:pt x="3443" y="26735"/>
                  </a:lnTo>
                  <a:lnTo>
                    <a:pt x="0" y="43815"/>
                  </a:lnTo>
                  <a:lnTo>
                    <a:pt x="0" y="1233170"/>
                  </a:lnTo>
                  <a:lnTo>
                    <a:pt x="3443" y="1250195"/>
                  </a:lnTo>
                  <a:lnTo>
                    <a:pt x="12834" y="1264126"/>
                  </a:lnTo>
                  <a:lnTo>
                    <a:pt x="26762" y="1273532"/>
                  </a:lnTo>
                  <a:lnTo>
                    <a:pt x="43815" y="1276985"/>
                  </a:lnTo>
                  <a:lnTo>
                    <a:pt x="219075" y="1276985"/>
                  </a:lnTo>
                  <a:lnTo>
                    <a:pt x="236127" y="1273532"/>
                  </a:lnTo>
                  <a:lnTo>
                    <a:pt x="250055" y="1264126"/>
                  </a:lnTo>
                  <a:lnTo>
                    <a:pt x="259446" y="1250195"/>
                  </a:lnTo>
                  <a:lnTo>
                    <a:pt x="262889" y="1233170"/>
                  </a:lnTo>
                  <a:lnTo>
                    <a:pt x="262889" y="43815"/>
                  </a:lnTo>
                  <a:lnTo>
                    <a:pt x="259446" y="26735"/>
                  </a:lnTo>
                  <a:lnTo>
                    <a:pt x="250055" y="12811"/>
                  </a:lnTo>
                  <a:lnTo>
                    <a:pt x="236127" y="3434"/>
                  </a:lnTo>
                  <a:lnTo>
                    <a:pt x="219075" y="0"/>
                  </a:lnTo>
                  <a:close/>
                </a:path>
              </a:pathLst>
            </a:custGeom>
            <a:solidFill>
              <a:srgbClr val="CDECFF"/>
            </a:solidFill>
            <a:ln w="12700">
              <a:solidFill>
                <a:schemeClr val="tx1"/>
              </a:solidFill>
            </a:ln>
          </p:spPr>
          <p:txBody>
            <a:bodyPr vert="vert270" wrap="square" lIns="0" tIns="0" rIns="0" bIns="0" rtlCol="0" anchor="ctr"/>
            <a:lstStyle/>
            <a:p>
              <a:pPr algn="ctr"/>
              <a:r>
                <a:rPr lang="en-US" altLang="zh-CN" sz="1200" b="1" spc="-10" dirty="0">
                  <a:latin typeface="Arial"/>
                  <a:cs typeface="Arial"/>
                </a:rPr>
                <a:t>Identification</a:t>
              </a:r>
              <a:endParaRPr lang="en-US" altLang="zh-CN" sz="1200" b="1" dirty="0">
                <a:latin typeface="Arial"/>
                <a:cs typeface="Arial"/>
              </a:endParaRPr>
            </a:p>
          </p:txBody>
        </p:sp>
        <p:sp>
          <p:nvSpPr>
            <p:cNvPr id="9" name="object 20">
              <a:extLst>
                <a:ext uri="{FF2B5EF4-FFF2-40B4-BE49-F238E27FC236}">
                  <a16:creationId xmlns:a16="http://schemas.microsoft.com/office/drawing/2014/main" id="{954CBDE5-7058-A841-479D-AD86CC4ECA4B}"/>
                </a:ext>
              </a:extLst>
            </p:cNvPr>
            <p:cNvSpPr/>
            <p:nvPr/>
          </p:nvSpPr>
          <p:spPr>
            <a:xfrm>
              <a:off x="256894" y="2168216"/>
              <a:ext cx="262340" cy="1417320"/>
            </a:xfrm>
            <a:custGeom>
              <a:avLst/>
              <a:gdLst/>
              <a:ahLst/>
              <a:cxnLst/>
              <a:rect l="l" t="t" r="r" b="b"/>
              <a:pathLst>
                <a:path w="262890" h="1276985">
                  <a:moveTo>
                    <a:pt x="219075" y="0"/>
                  </a:moveTo>
                  <a:lnTo>
                    <a:pt x="43815" y="0"/>
                  </a:lnTo>
                  <a:lnTo>
                    <a:pt x="26762" y="3434"/>
                  </a:lnTo>
                  <a:lnTo>
                    <a:pt x="12834" y="12811"/>
                  </a:lnTo>
                  <a:lnTo>
                    <a:pt x="3443" y="26735"/>
                  </a:lnTo>
                  <a:lnTo>
                    <a:pt x="0" y="43815"/>
                  </a:lnTo>
                  <a:lnTo>
                    <a:pt x="0" y="1233170"/>
                  </a:lnTo>
                  <a:lnTo>
                    <a:pt x="3443" y="1250195"/>
                  </a:lnTo>
                  <a:lnTo>
                    <a:pt x="12834" y="1264126"/>
                  </a:lnTo>
                  <a:lnTo>
                    <a:pt x="26762" y="1273532"/>
                  </a:lnTo>
                  <a:lnTo>
                    <a:pt x="43815" y="1276985"/>
                  </a:lnTo>
                  <a:lnTo>
                    <a:pt x="219075" y="1276985"/>
                  </a:lnTo>
                  <a:lnTo>
                    <a:pt x="236127" y="1273532"/>
                  </a:lnTo>
                  <a:lnTo>
                    <a:pt x="250055" y="1264126"/>
                  </a:lnTo>
                  <a:lnTo>
                    <a:pt x="259446" y="1250195"/>
                  </a:lnTo>
                  <a:lnTo>
                    <a:pt x="262889" y="1233170"/>
                  </a:lnTo>
                  <a:lnTo>
                    <a:pt x="262889" y="43815"/>
                  </a:lnTo>
                  <a:lnTo>
                    <a:pt x="259446" y="26735"/>
                  </a:lnTo>
                  <a:lnTo>
                    <a:pt x="250055" y="12811"/>
                  </a:lnTo>
                  <a:lnTo>
                    <a:pt x="236127" y="3434"/>
                  </a:lnTo>
                  <a:lnTo>
                    <a:pt x="219075" y="0"/>
                  </a:lnTo>
                  <a:close/>
                </a:path>
              </a:pathLst>
            </a:custGeom>
            <a:solidFill>
              <a:srgbClr val="CDECFF"/>
            </a:solidFill>
            <a:ln w="12700">
              <a:solidFill>
                <a:schemeClr val="tx1"/>
              </a:solidFill>
            </a:ln>
          </p:spPr>
          <p:txBody>
            <a:bodyPr vert="vert270" wrap="square" lIns="0" tIns="0" rIns="0" bIns="0" rtlCol="0" anchor="ctr"/>
            <a:lstStyle/>
            <a:p>
              <a:pPr algn="ctr"/>
              <a:r>
                <a:rPr lang="en-US" altLang="zh-CN" sz="1200" b="1" spc="-10" dirty="0">
                  <a:latin typeface="Arial"/>
                  <a:cs typeface="Arial"/>
                </a:rPr>
                <a:t>Screening</a:t>
              </a:r>
              <a:endParaRPr lang="en-US" altLang="zh-CN" sz="1200" b="1" dirty="0">
                <a:latin typeface="Arial"/>
                <a:cs typeface="Arial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FB567AC9-04BF-A1FB-33C0-D6493D5D8C04}"/>
                </a:ext>
              </a:extLst>
            </p:cNvPr>
            <p:cNvSpPr/>
            <p:nvPr/>
          </p:nvSpPr>
          <p:spPr>
            <a:xfrm>
              <a:off x="1023564" y="1670913"/>
              <a:ext cx="2299934" cy="52578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after duplicates removed (n=1690)</a:t>
              </a:r>
            </a:p>
          </p:txBody>
        </p:sp>
        <p:cxnSp>
          <p:nvCxnSpPr>
            <p:cNvPr id="11" name="直接箭头连接符 10">
              <a:extLst>
                <a:ext uri="{FF2B5EF4-FFF2-40B4-BE49-F238E27FC236}">
                  <a16:creationId xmlns:a16="http://schemas.microsoft.com/office/drawing/2014/main" id="{5AEF41C1-9447-ADF9-59F9-4C7E41D6013D}"/>
                </a:ext>
              </a:extLst>
            </p:cNvPr>
            <p:cNvCxnSpPr>
              <a:cxnSpLocks/>
              <a:stCxn id="7" idx="2"/>
              <a:endCxn id="10" idx="0"/>
            </p:cNvCxnSpPr>
            <p:nvPr/>
          </p:nvCxnSpPr>
          <p:spPr>
            <a:xfrm flipH="1">
              <a:off x="2173531" y="1360385"/>
              <a:ext cx="2" cy="310528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7DB44380-EB03-6394-2541-EFCA2D48A103}"/>
                </a:ext>
              </a:extLst>
            </p:cNvPr>
            <p:cNvSpPr/>
            <p:nvPr/>
          </p:nvSpPr>
          <p:spPr>
            <a:xfrm>
              <a:off x="3683417" y="1435692"/>
              <a:ext cx="2299920" cy="52578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uplicates excluded by EndNote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903)</a:t>
              </a:r>
            </a:p>
          </p:txBody>
        </p: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2C034BF6-8256-62C9-C66F-635FA7E62325}"/>
                </a:ext>
              </a:extLst>
            </p:cNvPr>
            <p:cNvCxnSpPr>
              <a:cxnSpLocks/>
              <a:stCxn id="16" idx="3"/>
              <a:endCxn id="18" idx="1"/>
            </p:cNvCxnSpPr>
            <p:nvPr/>
          </p:nvCxnSpPr>
          <p:spPr>
            <a:xfrm>
              <a:off x="3087928" y="2876876"/>
              <a:ext cx="599929" cy="1042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object 20">
              <a:extLst>
                <a:ext uri="{FF2B5EF4-FFF2-40B4-BE49-F238E27FC236}">
                  <a16:creationId xmlns:a16="http://schemas.microsoft.com/office/drawing/2014/main" id="{533BBAB3-D0CC-84D4-831C-95F694BF9234}"/>
                </a:ext>
              </a:extLst>
            </p:cNvPr>
            <p:cNvSpPr/>
            <p:nvPr/>
          </p:nvSpPr>
          <p:spPr>
            <a:xfrm>
              <a:off x="254287" y="3684596"/>
              <a:ext cx="262340" cy="1417320"/>
            </a:xfrm>
            <a:custGeom>
              <a:avLst/>
              <a:gdLst/>
              <a:ahLst/>
              <a:cxnLst/>
              <a:rect l="l" t="t" r="r" b="b"/>
              <a:pathLst>
                <a:path w="262890" h="1276985">
                  <a:moveTo>
                    <a:pt x="219075" y="0"/>
                  </a:moveTo>
                  <a:lnTo>
                    <a:pt x="43815" y="0"/>
                  </a:lnTo>
                  <a:lnTo>
                    <a:pt x="26762" y="3434"/>
                  </a:lnTo>
                  <a:lnTo>
                    <a:pt x="12834" y="12811"/>
                  </a:lnTo>
                  <a:lnTo>
                    <a:pt x="3443" y="26735"/>
                  </a:lnTo>
                  <a:lnTo>
                    <a:pt x="0" y="43815"/>
                  </a:lnTo>
                  <a:lnTo>
                    <a:pt x="0" y="1233170"/>
                  </a:lnTo>
                  <a:lnTo>
                    <a:pt x="3443" y="1250195"/>
                  </a:lnTo>
                  <a:lnTo>
                    <a:pt x="12834" y="1264126"/>
                  </a:lnTo>
                  <a:lnTo>
                    <a:pt x="26762" y="1273532"/>
                  </a:lnTo>
                  <a:lnTo>
                    <a:pt x="43815" y="1276985"/>
                  </a:lnTo>
                  <a:lnTo>
                    <a:pt x="219075" y="1276985"/>
                  </a:lnTo>
                  <a:lnTo>
                    <a:pt x="236127" y="1273532"/>
                  </a:lnTo>
                  <a:lnTo>
                    <a:pt x="250055" y="1264126"/>
                  </a:lnTo>
                  <a:lnTo>
                    <a:pt x="259446" y="1250195"/>
                  </a:lnTo>
                  <a:lnTo>
                    <a:pt x="262889" y="1233170"/>
                  </a:lnTo>
                  <a:lnTo>
                    <a:pt x="262889" y="43815"/>
                  </a:lnTo>
                  <a:lnTo>
                    <a:pt x="259446" y="26735"/>
                  </a:lnTo>
                  <a:lnTo>
                    <a:pt x="250055" y="12811"/>
                  </a:lnTo>
                  <a:lnTo>
                    <a:pt x="236127" y="3434"/>
                  </a:lnTo>
                  <a:lnTo>
                    <a:pt x="219075" y="0"/>
                  </a:lnTo>
                  <a:close/>
                </a:path>
              </a:pathLst>
            </a:custGeom>
            <a:solidFill>
              <a:srgbClr val="CDECFF"/>
            </a:solidFill>
            <a:ln w="12700">
              <a:solidFill>
                <a:schemeClr val="tx1"/>
              </a:solidFill>
            </a:ln>
          </p:spPr>
          <p:txBody>
            <a:bodyPr vert="vert270" wrap="square" lIns="0" tIns="0" rIns="0" bIns="0" rtlCol="0" anchor="ctr"/>
            <a:lstStyle/>
            <a:p>
              <a:pPr algn="ctr"/>
              <a:r>
                <a:rPr lang="en-US" altLang="zh-CN" sz="1200" b="1" spc="-10" dirty="0">
                  <a:latin typeface="Arial"/>
                  <a:cs typeface="Arial"/>
                </a:rPr>
                <a:t>Eligibility</a:t>
              </a:r>
            </a:p>
          </p:txBody>
        </p:sp>
        <p:sp>
          <p:nvSpPr>
            <p:cNvPr id="15" name="object 20">
              <a:extLst>
                <a:ext uri="{FF2B5EF4-FFF2-40B4-BE49-F238E27FC236}">
                  <a16:creationId xmlns:a16="http://schemas.microsoft.com/office/drawing/2014/main" id="{D4796FE9-E576-B430-B110-6A9FA5C1F38E}"/>
                </a:ext>
              </a:extLst>
            </p:cNvPr>
            <p:cNvSpPr/>
            <p:nvPr/>
          </p:nvSpPr>
          <p:spPr>
            <a:xfrm>
              <a:off x="254287" y="5200976"/>
              <a:ext cx="262340" cy="1417320"/>
            </a:xfrm>
            <a:custGeom>
              <a:avLst/>
              <a:gdLst/>
              <a:ahLst/>
              <a:cxnLst/>
              <a:rect l="l" t="t" r="r" b="b"/>
              <a:pathLst>
                <a:path w="262890" h="1276985">
                  <a:moveTo>
                    <a:pt x="219075" y="0"/>
                  </a:moveTo>
                  <a:lnTo>
                    <a:pt x="43815" y="0"/>
                  </a:lnTo>
                  <a:lnTo>
                    <a:pt x="26762" y="3434"/>
                  </a:lnTo>
                  <a:lnTo>
                    <a:pt x="12834" y="12811"/>
                  </a:lnTo>
                  <a:lnTo>
                    <a:pt x="3443" y="26735"/>
                  </a:lnTo>
                  <a:lnTo>
                    <a:pt x="0" y="43815"/>
                  </a:lnTo>
                  <a:lnTo>
                    <a:pt x="0" y="1233170"/>
                  </a:lnTo>
                  <a:lnTo>
                    <a:pt x="3443" y="1250195"/>
                  </a:lnTo>
                  <a:lnTo>
                    <a:pt x="12834" y="1264126"/>
                  </a:lnTo>
                  <a:lnTo>
                    <a:pt x="26762" y="1273532"/>
                  </a:lnTo>
                  <a:lnTo>
                    <a:pt x="43815" y="1276985"/>
                  </a:lnTo>
                  <a:lnTo>
                    <a:pt x="219075" y="1276985"/>
                  </a:lnTo>
                  <a:lnTo>
                    <a:pt x="236127" y="1273532"/>
                  </a:lnTo>
                  <a:lnTo>
                    <a:pt x="250055" y="1264126"/>
                  </a:lnTo>
                  <a:lnTo>
                    <a:pt x="259446" y="1250195"/>
                  </a:lnTo>
                  <a:lnTo>
                    <a:pt x="262889" y="1233170"/>
                  </a:lnTo>
                  <a:lnTo>
                    <a:pt x="262889" y="43815"/>
                  </a:lnTo>
                  <a:lnTo>
                    <a:pt x="259446" y="26735"/>
                  </a:lnTo>
                  <a:lnTo>
                    <a:pt x="250055" y="12811"/>
                  </a:lnTo>
                  <a:lnTo>
                    <a:pt x="236127" y="3434"/>
                  </a:lnTo>
                  <a:lnTo>
                    <a:pt x="219075" y="0"/>
                  </a:lnTo>
                  <a:close/>
                </a:path>
              </a:pathLst>
            </a:custGeom>
            <a:solidFill>
              <a:srgbClr val="CDECFF"/>
            </a:solidFill>
            <a:ln w="12700">
              <a:solidFill>
                <a:schemeClr val="tx1"/>
              </a:solidFill>
            </a:ln>
          </p:spPr>
          <p:txBody>
            <a:bodyPr vert="vert270" wrap="square" lIns="0" tIns="0" rIns="0" bIns="0" rtlCol="0" anchor="ctr"/>
            <a:lstStyle/>
            <a:p>
              <a:pPr algn="ctr"/>
              <a:r>
                <a:rPr lang="en-US" altLang="zh-CN" sz="1200" b="1" spc="-10" dirty="0">
                  <a:latin typeface="Arial"/>
                  <a:cs typeface="Arial"/>
                </a:rPr>
                <a:t>Included</a:t>
              </a: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97C1A87F-4792-AA04-4708-E67C372E3636}"/>
                </a:ext>
              </a:extLst>
            </p:cNvPr>
            <p:cNvSpPr/>
            <p:nvPr/>
          </p:nvSpPr>
          <p:spPr>
            <a:xfrm>
              <a:off x="1259135" y="2507222"/>
              <a:ext cx="1828793" cy="739308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screened based on tittle and abstract 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1690)</a:t>
              </a:r>
            </a:p>
          </p:txBody>
        </p:sp>
        <p:cxnSp>
          <p:nvCxnSpPr>
            <p:cNvPr id="17" name="直接箭头连接符 16">
              <a:extLst>
                <a:ext uri="{FF2B5EF4-FFF2-40B4-BE49-F238E27FC236}">
                  <a16:creationId xmlns:a16="http://schemas.microsoft.com/office/drawing/2014/main" id="{2623929B-0D53-4ECE-5213-6E478BA58B86}"/>
                </a:ext>
              </a:extLst>
            </p:cNvPr>
            <p:cNvCxnSpPr>
              <a:cxnSpLocks/>
              <a:stCxn id="23" idx="3"/>
            </p:cNvCxnSpPr>
            <p:nvPr/>
          </p:nvCxnSpPr>
          <p:spPr>
            <a:xfrm>
              <a:off x="2952673" y="4016068"/>
              <a:ext cx="730741" cy="0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874E44A0-2A06-6292-1F4A-F51B3327E12E}"/>
                </a:ext>
              </a:extLst>
            </p:cNvPr>
            <p:cNvSpPr/>
            <p:nvPr/>
          </p:nvSpPr>
          <p:spPr>
            <a:xfrm>
              <a:off x="3687857" y="2120272"/>
              <a:ext cx="2295480" cy="1515291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rds excluded: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e reports (n=74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views (n=197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English language records (n=212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rrelevant records (n=983) 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1466)</a:t>
              </a:r>
            </a:p>
          </p:txBody>
        </p:sp>
        <p:cxnSp>
          <p:nvCxnSpPr>
            <p:cNvPr id="19" name="直接箭头连接符 18">
              <a:extLst>
                <a:ext uri="{FF2B5EF4-FFF2-40B4-BE49-F238E27FC236}">
                  <a16:creationId xmlns:a16="http://schemas.microsoft.com/office/drawing/2014/main" id="{092F15EC-CB69-CB2E-BC59-7FE54B4751C3}"/>
                </a:ext>
              </a:extLst>
            </p:cNvPr>
            <p:cNvCxnSpPr>
              <a:cxnSpLocks/>
            </p:cNvCxnSpPr>
            <p:nvPr/>
          </p:nvCxnSpPr>
          <p:spPr>
            <a:xfrm>
              <a:off x="2173530" y="1515649"/>
              <a:ext cx="1509887" cy="0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64690F55-0C8C-B839-1D99-5047CF6317AF}"/>
                </a:ext>
              </a:extLst>
            </p:cNvPr>
            <p:cNvSpPr/>
            <p:nvPr/>
          </p:nvSpPr>
          <p:spPr>
            <a:xfrm>
              <a:off x="1394388" y="4748594"/>
              <a:ext cx="1558286" cy="739309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ies included in quality assessment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9)</a:t>
              </a: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3C2E5E10-9509-A398-3D58-11AAC17880B3}"/>
                </a:ext>
              </a:extLst>
            </p:cNvPr>
            <p:cNvSpPr/>
            <p:nvPr/>
          </p:nvSpPr>
          <p:spPr>
            <a:xfrm>
              <a:off x="1259135" y="5878988"/>
              <a:ext cx="1828793" cy="739308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ies included in the systematic review and meta-analysis (n=9)</a:t>
              </a: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CF74372B-F0C4-A273-3347-8A4A55557CD2}"/>
                </a:ext>
              </a:extLst>
            </p:cNvPr>
            <p:cNvSpPr/>
            <p:nvPr/>
          </p:nvSpPr>
          <p:spPr>
            <a:xfrm>
              <a:off x="3683414" y="3794434"/>
              <a:ext cx="2299918" cy="186182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ticles excluded: 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 related data (n=152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 quality studies (n=24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bsence of control group (n=18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ies on second-trimester medical abortions (n=17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sufficient data (n=4),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215)</a:t>
              </a: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8100E4EC-2912-E7EB-F05F-8ECF20215DB2}"/>
                </a:ext>
              </a:extLst>
            </p:cNvPr>
            <p:cNvSpPr/>
            <p:nvPr/>
          </p:nvSpPr>
          <p:spPr>
            <a:xfrm>
              <a:off x="1394388" y="3684596"/>
              <a:ext cx="1558285" cy="662943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ull-text articles assessed for eligibility</a:t>
              </a:r>
            </a:p>
            <a:p>
              <a:pPr algn="ctr">
                <a:lnSpc>
                  <a:spcPct val="125000"/>
                </a:lnSpc>
              </a:pPr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n=224)</a:t>
              </a:r>
            </a:p>
          </p:txBody>
        </p:sp>
        <p:cxnSp>
          <p:nvCxnSpPr>
            <p:cNvPr id="24" name="直接箭头连接符 23">
              <a:extLst>
                <a:ext uri="{FF2B5EF4-FFF2-40B4-BE49-F238E27FC236}">
                  <a16:creationId xmlns:a16="http://schemas.microsoft.com/office/drawing/2014/main" id="{55D95273-D42C-F88E-235B-942678DD59F6}"/>
                </a:ext>
              </a:extLst>
            </p:cNvPr>
            <p:cNvCxnSpPr>
              <a:cxnSpLocks/>
              <a:stCxn id="10" idx="2"/>
              <a:endCxn id="16" idx="0"/>
            </p:cNvCxnSpPr>
            <p:nvPr/>
          </p:nvCxnSpPr>
          <p:spPr>
            <a:xfrm>
              <a:off x="2173531" y="2196693"/>
              <a:ext cx="1" cy="310529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>
              <a:extLst>
                <a:ext uri="{FF2B5EF4-FFF2-40B4-BE49-F238E27FC236}">
                  <a16:creationId xmlns:a16="http://schemas.microsoft.com/office/drawing/2014/main" id="{F3891258-8267-88D9-2F21-C7363589F1E0}"/>
                </a:ext>
              </a:extLst>
            </p:cNvPr>
            <p:cNvCxnSpPr>
              <a:cxnSpLocks/>
              <a:stCxn id="16" idx="2"/>
              <a:endCxn id="23" idx="0"/>
            </p:cNvCxnSpPr>
            <p:nvPr/>
          </p:nvCxnSpPr>
          <p:spPr>
            <a:xfrm flipH="1">
              <a:off x="2173531" y="3246530"/>
              <a:ext cx="1" cy="438066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箭头连接符 25">
              <a:extLst>
                <a:ext uri="{FF2B5EF4-FFF2-40B4-BE49-F238E27FC236}">
                  <a16:creationId xmlns:a16="http://schemas.microsoft.com/office/drawing/2014/main" id="{B1D6E854-E1CC-C143-7E01-3A34AAF54BA4}"/>
                </a:ext>
              </a:extLst>
            </p:cNvPr>
            <p:cNvCxnSpPr>
              <a:cxnSpLocks/>
              <a:stCxn id="23" idx="2"/>
              <a:endCxn id="20" idx="0"/>
            </p:cNvCxnSpPr>
            <p:nvPr/>
          </p:nvCxnSpPr>
          <p:spPr>
            <a:xfrm>
              <a:off x="2173531" y="4347539"/>
              <a:ext cx="0" cy="401055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箭头连接符 26">
              <a:extLst>
                <a:ext uri="{FF2B5EF4-FFF2-40B4-BE49-F238E27FC236}">
                  <a16:creationId xmlns:a16="http://schemas.microsoft.com/office/drawing/2014/main" id="{91AEFB31-0293-9262-3F31-BF46136C1DDF}"/>
                </a:ext>
              </a:extLst>
            </p:cNvPr>
            <p:cNvCxnSpPr>
              <a:cxnSpLocks/>
              <a:stCxn id="20" idx="2"/>
              <a:endCxn id="21" idx="0"/>
            </p:cNvCxnSpPr>
            <p:nvPr/>
          </p:nvCxnSpPr>
          <p:spPr>
            <a:xfrm>
              <a:off x="2173531" y="5487903"/>
              <a:ext cx="1" cy="391085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object 16">
              <a:extLst>
                <a:ext uri="{FF2B5EF4-FFF2-40B4-BE49-F238E27FC236}">
                  <a16:creationId xmlns:a16="http://schemas.microsoft.com/office/drawing/2014/main" id="{EB9D3972-EF22-84B1-2ABB-30DC79139527}"/>
                </a:ext>
              </a:extLst>
            </p:cNvPr>
            <p:cNvSpPr/>
            <p:nvPr/>
          </p:nvSpPr>
          <p:spPr>
            <a:xfrm>
              <a:off x="691443" y="239703"/>
              <a:ext cx="5291894" cy="262340"/>
            </a:xfrm>
            <a:custGeom>
              <a:avLst/>
              <a:gdLst/>
              <a:ahLst/>
              <a:cxnLst/>
              <a:rect l="l" t="t" r="r" b="b"/>
              <a:pathLst>
                <a:path w="4344670" h="262890">
                  <a:moveTo>
                    <a:pt x="4300855" y="0"/>
                  </a:moveTo>
                  <a:lnTo>
                    <a:pt x="43815" y="0"/>
                  </a:lnTo>
                  <a:lnTo>
                    <a:pt x="26762" y="3434"/>
                  </a:lnTo>
                  <a:lnTo>
                    <a:pt x="12834" y="12811"/>
                  </a:lnTo>
                  <a:lnTo>
                    <a:pt x="3443" y="26735"/>
                  </a:lnTo>
                  <a:lnTo>
                    <a:pt x="0" y="43815"/>
                  </a:lnTo>
                  <a:lnTo>
                    <a:pt x="0" y="219075"/>
                  </a:lnTo>
                  <a:lnTo>
                    <a:pt x="3443" y="236100"/>
                  </a:lnTo>
                  <a:lnTo>
                    <a:pt x="12834" y="250031"/>
                  </a:lnTo>
                  <a:lnTo>
                    <a:pt x="26762" y="259437"/>
                  </a:lnTo>
                  <a:lnTo>
                    <a:pt x="43815" y="262890"/>
                  </a:lnTo>
                  <a:lnTo>
                    <a:pt x="4300855" y="262890"/>
                  </a:lnTo>
                  <a:lnTo>
                    <a:pt x="4317934" y="259437"/>
                  </a:lnTo>
                  <a:lnTo>
                    <a:pt x="4331858" y="250031"/>
                  </a:lnTo>
                  <a:lnTo>
                    <a:pt x="4341235" y="236100"/>
                  </a:lnTo>
                  <a:lnTo>
                    <a:pt x="4344670" y="219075"/>
                  </a:lnTo>
                  <a:lnTo>
                    <a:pt x="4344670" y="43815"/>
                  </a:lnTo>
                  <a:lnTo>
                    <a:pt x="4341235" y="26735"/>
                  </a:lnTo>
                  <a:lnTo>
                    <a:pt x="4331858" y="12811"/>
                  </a:lnTo>
                  <a:lnTo>
                    <a:pt x="4317934" y="3434"/>
                  </a:lnTo>
                  <a:lnTo>
                    <a:pt x="4300855" y="0"/>
                  </a:lnTo>
                  <a:close/>
                </a:path>
              </a:pathLst>
            </a:custGeom>
            <a:solidFill>
              <a:srgbClr val="FFC000"/>
            </a:solidFill>
            <a:ln w="12700">
              <a:solidFill>
                <a:schemeClr val="tx1"/>
              </a:solidFill>
            </a:ln>
          </p:spPr>
          <p:txBody>
            <a:bodyPr wrap="square" lIns="0" tIns="0" rIns="0" bIns="0" rtlCol="0" anchor="ctr"/>
            <a:lstStyle/>
            <a:p>
              <a:pPr algn="ctr"/>
              <a:r>
                <a:rPr lang="en-US" altLang="zh-CN" sz="1200" b="1" dirty="0">
                  <a:latin typeface="Arial"/>
                  <a:cs typeface="Arial"/>
                </a:rPr>
                <a:t>Identification</a:t>
              </a:r>
              <a:r>
                <a:rPr lang="en-US" altLang="zh-CN" sz="1200" b="1" spc="-15" dirty="0">
                  <a:latin typeface="Arial"/>
                  <a:cs typeface="Arial"/>
                </a:rPr>
                <a:t> </a:t>
              </a:r>
              <a:r>
                <a:rPr lang="en-US" altLang="zh-CN" sz="1200" b="1" dirty="0">
                  <a:latin typeface="Arial"/>
                  <a:cs typeface="Arial"/>
                </a:rPr>
                <a:t>of</a:t>
              </a:r>
              <a:r>
                <a:rPr lang="en-US" altLang="zh-CN" sz="1200" b="1" spc="-5" dirty="0">
                  <a:latin typeface="Arial"/>
                  <a:cs typeface="Arial"/>
                </a:rPr>
                <a:t> relevant </a:t>
              </a:r>
              <a:r>
                <a:rPr lang="en-US" altLang="zh-CN" sz="1200" b="1" dirty="0">
                  <a:latin typeface="Arial"/>
                  <a:cs typeface="Arial"/>
                </a:rPr>
                <a:t>studies</a:t>
              </a:r>
              <a:r>
                <a:rPr lang="en-US" altLang="zh-CN" sz="1200" b="1" spc="-10" dirty="0">
                  <a:latin typeface="Arial"/>
                  <a:cs typeface="Arial"/>
                </a:rPr>
                <a:t> </a:t>
              </a:r>
              <a:r>
                <a:rPr lang="en-US" altLang="zh-CN" sz="1200" b="1" dirty="0">
                  <a:latin typeface="Arial"/>
                  <a:cs typeface="Arial"/>
                </a:rPr>
                <a:t>via</a:t>
              </a:r>
              <a:r>
                <a:rPr lang="en-US" altLang="zh-CN" sz="1200" b="1" spc="-10" dirty="0">
                  <a:latin typeface="Arial"/>
                  <a:cs typeface="Arial"/>
                </a:rPr>
                <a:t> </a:t>
              </a:r>
              <a:r>
                <a:rPr lang="en-US" altLang="zh-CN" sz="1200" b="1" dirty="0">
                  <a:latin typeface="Arial"/>
                  <a:cs typeface="Arial"/>
                </a:rPr>
                <a:t>databases</a:t>
              </a:r>
              <a:endParaRPr sz="1200" b="1" dirty="0"/>
            </a:p>
          </p:txBody>
        </p:sp>
      </p:grpSp>
      <p:sp>
        <p:nvSpPr>
          <p:cNvPr id="28" name="矩形 27">
            <a:extLst>
              <a:ext uri="{FF2B5EF4-FFF2-40B4-BE49-F238E27FC236}">
                <a16:creationId xmlns:a16="http://schemas.microsoft.com/office/drawing/2014/main" id="{AB6DBFC9-8137-19D2-0C3A-67FEDB1139E7}"/>
              </a:ext>
            </a:extLst>
          </p:cNvPr>
          <p:cNvSpPr/>
          <p:nvPr/>
        </p:nvSpPr>
        <p:spPr>
          <a:xfrm>
            <a:off x="7800977" y="2740341"/>
            <a:ext cx="4070587" cy="13773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PRISMA flow chart of the literature selection process.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SMA, preferred reporting items for systematic reviews and meta-analyses. </a:t>
            </a:r>
          </a:p>
        </p:txBody>
      </p:sp>
    </p:spTree>
    <p:extLst>
      <p:ext uri="{BB962C8B-B14F-4D97-AF65-F5344CB8AC3E}">
        <p14:creationId xmlns:p14="http://schemas.microsoft.com/office/powerpoint/2010/main" val="3198094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202</Words>
  <Application>Microsoft Office PowerPoint</Application>
  <PresentationFormat>宽屏</PresentationFormat>
  <Paragraphs>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安昊 刘</dc:creator>
  <cp:lastModifiedBy>Xun Chen</cp:lastModifiedBy>
  <cp:revision>12</cp:revision>
  <dcterms:created xsi:type="dcterms:W3CDTF">2024-01-23T06:56:39Z</dcterms:created>
  <dcterms:modified xsi:type="dcterms:W3CDTF">2024-10-02T12:35:31Z</dcterms:modified>
</cp:coreProperties>
</file>